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87" r:id="rId2"/>
    <p:sldId id="282" r:id="rId3"/>
  </p:sldIdLst>
  <p:sldSz cx="12192000" cy="6858000"/>
  <p:notesSz cx="7102475" cy="93884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5" userDrawn="1">
          <p15:clr>
            <a:srgbClr val="A4A3A4"/>
          </p15:clr>
        </p15:guide>
        <p15:guide id="2" pos="3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051"/>
    <a:srgbClr val="009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Destaqu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838" autoAdjust="0"/>
    <p:restoredTop sz="80988"/>
  </p:normalViewPr>
  <p:slideViewPr>
    <p:cSldViewPr snapToGrid="0" snapToObjects="1" showGuides="1">
      <p:cViewPr varScale="1">
        <p:scale>
          <a:sx n="114" d="100"/>
          <a:sy n="114" d="100"/>
        </p:scale>
        <p:origin x="480" y="102"/>
      </p:cViewPr>
      <p:guideLst>
        <p:guide orient="horz" pos="4315"/>
        <p:guide pos="3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akraborty, Anirban" userId="beb374dd-c17a-4851-a293-48dd327a1c1a" providerId="ADAL" clId="{3F04B7CA-D14B-4A9D-B7E4-FFBB170A514B}"/>
    <pc:docChg chg="undo custSel addSld delSld modSld">
      <pc:chgData name="Chakraborty, Anirban" userId="beb374dd-c17a-4851-a293-48dd327a1c1a" providerId="ADAL" clId="{3F04B7CA-D14B-4A9D-B7E4-FFBB170A514B}" dt="2023-09-19T13:24:44.470" v="8" actId="478"/>
      <pc:docMkLst>
        <pc:docMk/>
      </pc:docMkLst>
      <pc:sldChg chg="del">
        <pc:chgData name="Chakraborty, Anirban" userId="beb374dd-c17a-4851-a293-48dd327a1c1a" providerId="ADAL" clId="{3F04B7CA-D14B-4A9D-B7E4-FFBB170A514B}" dt="2023-09-19T13:24:07.863" v="0" actId="47"/>
        <pc:sldMkLst>
          <pc:docMk/>
          <pc:sldMk cId="1499400212" sldId="270"/>
        </pc:sldMkLst>
      </pc:sldChg>
      <pc:sldChg chg="del">
        <pc:chgData name="Chakraborty, Anirban" userId="beb374dd-c17a-4851-a293-48dd327a1c1a" providerId="ADAL" clId="{3F04B7CA-D14B-4A9D-B7E4-FFBB170A514B}" dt="2023-09-19T13:24:07.863" v="0" actId="47"/>
        <pc:sldMkLst>
          <pc:docMk/>
          <pc:sldMk cId="1362357393" sldId="271"/>
        </pc:sldMkLst>
      </pc:sldChg>
      <pc:sldChg chg="del">
        <pc:chgData name="Chakraborty, Anirban" userId="beb374dd-c17a-4851-a293-48dd327a1c1a" providerId="ADAL" clId="{3F04B7CA-D14B-4A9D-B7E4-FFBB170A514B}" dt="2023-09-19T13:24:07.863" v="0" actId="47"/>
        <pc:sldMkLst>
          <pc:docMk/>
          <pc:sldMk cId="3109744734" sldId="272"/>
        </pc:sldMkLst>
      </pc:sldChg>
      <pc:sldChg chg="del">
        <pc:chgData name="Chakraborty, Anirban" userId="beb374dd-c17a-4851-a293-48dd327a1c1a" providerId="ADAL" clId="{3F04B7CA-D14B-4A9D-B7E4-FFBB170A514B}" dt="2023-09-19T13:24:07.863" v="0" actId="47"/>
        <pc:sldMkLst>
          <pc:docMk/>
          <pc:sldMk cId="3096922174" sldId="274"/>
        </pc:sldMkLst>
      </pc:sldChg>
      <pc:sldChg chg="del">
        <pc:chgData name="Chakraborty, Anirban" userId="beb374dd-c17a-4851-a293-48dd327a1c1a" providerId="ADAL" clId="{3F04B7CA-D14B-4A9D-B7E4-FFBB170A514B}" dt="2023-09-19T13:24:07.863" v="0" actId="47"/>
        <pc:sldMkLst>
          <pc:docMk/>
          <pc:sldMk cId="2573754816" sldId="276"/>
        </pc:sldMkLst>
      </pc:sldChg>
      <pc:sldChg chg="del">
        <pc:chgData name="Chakraborty, Anirban" userId="beb374dd-c17a-4851-a293-48dd327a1c1a" providerId="ADAL" clId="{3F04B7CA-D14B-4A9D-B7E4-FFBB170A514B}" dt="2023-09-19T13:24:07.863" v="0" actId="47"/>
        <pc:sldMkLst>
          <pc:docMk/>
          <pc:sldMk cId="550479794" sldId="278"/>
        </pc:sldMkLst>
      </pc:sldChg>
      <pc:sldChg chg="del">
        <pc:chgData name="Chakraborty, Anirban" userId="beb374dd-c17a-4851-a293-48dd327a1c1a" providerId="ADAL" clId="{3F04B7CA-D14B-4A9D-B7E4-FFBB170A514B}" dt="2023-09-19T13:24:11.308" v="1" actId="47"/>
        <pc:sldMkLst>
          <pc:docMk/>
          <pc:sldMk cId="3002076954" sldId="279"/>
        </pc:sldMkLst>
      </pc:sldChg>
      <pc:sldChg chg="add del">
        <pc:chgData name="Chakraborty, Anirban" userId="beb374dd-c17a-4851-a293-48dd327a1c1a" providerId="ADAL" clId="{3F04B7CA-D14B-4A9D-B7E4-FFBB170A514B}" dt="2023-09-19T13:24:29.083" v="4" actId="47"/>
        <pc:sldMkLst>
          <pc:docMk/>
          <pc:sldMk cId="3852428335" sldId="280"/>
        </pc:sldMkLst>
      </pc:sldChg>
      <pc:sldChg chg="add del">
        <pc:chgData name="Chakraborty, Anirban" userId="beb374dd-c17a-4851-a293-48dd327a1c1a" providerId="ADAL" clId="{3F04B7CA-D14B-4A9D-B7E4-FFBB170A514B}" dt="2023-09-19T13:24:29.083" v="4" actId="47"/>
        <pc:sldMkLst>
          <pc:docMk/>
          <pc:sldMk cId="1026364918" sldId="281"/>
        </pc:sldMkLst>
      </pc:sldChg>
      <pc:sldChg chg="delSp mod">
        <pc:chgData name="Chakraborty, Anirban" userId="beb374dd-c17a-4851-a293-48dd327a1c1a" providerId="ADAL" clId="{3F04B7CA-D14B-4A9D-B7E4-FFBB170A514B}" dt="2023-09-19T13:24:44.470" v="8" actId="478"/>
        <pc:sldMkLst>
          <pc:docMk/>
          <pc:sldMk cId="2329365240" sldId="282"/>
        </pc:sldMkLst>
        <pc:spChg chg="del">
          <ac:chgData name="Chakraborty, Anirban" userId="beb374dd-c17a-4851-a293-48dd327a1c1a" providerId="ADAL" clId="{3F04B7CA-D14B-4A9D-B7E4-FFBB170A514B}" dt="2023-09-19T13:24:44.470" v="8" actId="478"/>
          <ac:spMkLst>
            <pc:docMk/>
            <pc:sldMk cId="2329365240" sldId="282"/>
            <ac:spMk id="3" creationId="{00000000-0000-0000-0000-000000000000}"/>
          </ac:spMkLst>
        </pc:spChg>
      </pc:sldChg>
      <pc:sldChg chg="add del">
        <pc:chgData name="Chakraborty, Anirban" userId="beb374dd-c17a-4851-a293-48dd327a1c1a" providerId="ADAL" clId="{3F04B7CA-D14B-4A9D-B7E4-FFBB170A514B}" dt="2023-09-19T13:24:36.884" v="7" actId="47"/>
        <pc:sldMkLst>
          <pc:docMk/>
          <pc:sldMk cId="438658365" sldId="284"/>
        </pc:sldMkLst>
      </pc:sldChg>
      <pc:sldChg chg="add del">
        <pc:chgData name="Chakraborty, Anirban" userId="beb374dd-c17a-4851-a293-48dd327a1c1a" providerId="ADAL" clId="{3F04B7CA-D14B-4A9D-B7E4-FFBB170A514B}" dt="2023-09-19T13:24:29.083" v="4" actId="47"/>
        <pc:sldMkLst>
          <pc:docMk/>
          <pc:sldMk cId="1305156795" sldId="285"/>
        </pc:sldMkLst>
      </pc:sldChg>
      <pc:sldChg chg="add del">
        <pc:chgData name="Chakraborty, Anirban" userId="beb374dd-c17a-4851-a293-48dd327a1c1a" providerId="ADAL" clId="{3F04B7CA-D14B-4A9D-B7E4-FFBB170A514B}" dt="2023-09-19T13:24:29.083" v="4" actId="47"/>
        <pc:sldMkLst>
          <pc:docMk/>
          <pc:sldMk cId="4028044274" sldId="286"/>
        </pc:sldMkLst>
      </pc:sldChg>
      <pc:sldChg chg="add del">
        <pc:chgData name="Chakraborty, Anirban" userId="beb374dd-c17a-4851-a293-48dd327a1c1a" providerId="ADAL" clId="{3F04B7CA-D14B-4A9D-B7E4-FFBB170A514B}" dt="2023-09-19T13:24:34.056" v="6" actId="47"/>
        <pc:sldMkLst>
          <pc:docMk/>
          <pc:sldMk cId="256142667" sldId="287"/>
        </pc:sldMkLst>
      </pc:sldChg>
      <pc:sldChg chg="add del">
        <pc:chgData name="Chakraborty, Anirban" userId="beb374dd-c17a-4851-a293-48dd327a1c1a" providerId="ADAL" clId="{3F04B7CA-D14B-4A9D-B7E4-FFBB170A514B}" dt="2023-09-19T13:24:36.884" v="7" actId="47"/>
        <pc:sldMkLst>
          <pc:docMk/>
          <pc:sldMk cId="3421195017" sldId="28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7105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2" y="0"/>
            <a:ext cx="3077739" cy="47105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r">
              <a:defRPr sz="1200"/>
            </a:lvl1pPr>
          </a:lstStyle>
          <a:p>
            <a:fld id="{E8D3B8AE-E6A7-C943-834B-509E182B2575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73163"/>
            <a:ext cx="5632450" cy="31686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29" tIns="47114" rIns="94229" bIns="4711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518204"/>
            <a:ext cx="5681980" cy="3696712"/>
          </a:xfrm>
          <a:prstGeom prst="rect">
            <a:avLst/>
          </a:prstGeom>
        </p:spPr>
        <p:txBody>
          <a:bodyPr vert="horz" lIns="94229" tIns="47114" rIns="94229" bIns="47114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7422"/>
            <a:ext cx="3077739" cy="471053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2" y="8917422"/>
            <a:ext cx="3077739" cy="471053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r">
              <a:defRPr sz="1200"/>
            </a:lvl1pPr>
          </a:lstStyle>
          <a:p>
            <a:fld id="{F048A57D-F6E1-034D-9BC0-9C2FC71C8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2271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D2D4F7-2021-A642-B0CE-338B123010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CCA26C-5B50-B94F-82D6-8760696C27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986B55-454B-624D-A8D3-B1248D1B5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6245B3-23F0-9445-AE77-CA1A1FD8D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06163F-C787-3142-915E-C39148617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278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E13B3-C6AC-5A43-9ACB-B4BA394C2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B46718-2042-F04B-9FAD-3A485529EF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14F6B8-0A0A-AE4D-A494-4C95AE6C0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95348F-7B1A-4B46-B822-6736B2938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53BCF7-4449-3A4E-B494-1AFC21D8A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182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7DFC63B-84F7-4243-A5B4-1EC304FD4F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4AB81E-D3C6-C94C-A282-3BF98AFCD1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F9AD0D-7288-654F-956C-AD2593D6F5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E14BA3-1568-7241-BDAB-8CA5920E1C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464E63-C144-C745-A366-8399D40202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5814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94461C-9762-2342-A51E-38E476E7CB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24E9A-EA4E-1744-AF11-1D43DC789A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EC2680-0E9C-3144-862B-AFB3E69D4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DA7B78-FC12-D747-AAC1-F9FAD2ADC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8D220A-A23D-CA41-995A-E6A03A04E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9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7078E1-7996-144E-B8D4-476A685625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0D34C9-D05D-1E49-84C5-6333390D51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706A32-BAB0-E645-8BDF-589DD81C4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EABB79-D302-C944-A688-1B470D9DF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C1689D-4A8C-8E46-82E9-B3534632D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590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D3BDA4-9FCB-EE4C-810C-5C5661A10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51E0D0-4ABC-714F-89BF-8FCDBAE746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2CB25A-C5E7-D94D-B661-81D2A868C7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377595-6DF1-794D-A232-1C9958EDD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239CD3-9B4C-504C-879A-B4107E76E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AA483B-07C6-2043-8671-5B808FCA0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072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40A434-9C06-A042-A4F7-732F439847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32AE10-BF72-0049-A0E4-F4BA1C9927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8F7D1D-D036-B44B-9630-10A6978CF8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E2EEC0-124E-EC46-8D02-E81AD515A3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E4BCE2-4DE2-D24C-86A9-F1C6DF7249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C13A7F2-94A9-B349-9B3B-D0F826A3AB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CC8104-22AE-3045-9A1A-2FA341AFA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E858AB-36F4-684B-A9FE-18BB4BC0E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650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6DAA0F-1B23-4344-A407-89B3D606D8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1CE5D9-E60A-9F46-8E26-6AB7D3398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5FD3E93-5CF8-F348-A2F5-35068A6A2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692F73-EA23-F34A-B504-CD619EC2C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290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F41EA2-0F06-6444-967C-B8D532FB3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70B9B18-2F70-1048-BBA6-F718B5702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347B7B-3038-7141-BB16-7C04389F1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967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91EAD8-56A1-5E41-B7CA-A0A401B027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E040C8-CB84-0B4E-88B3-B0C73BBC46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122BAF-B99A-4E49-A59A-614A49394D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F12B9D-5CAD-3A41-8FBA-DC8923E9A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1579BE-E6ED-F945-ABE3-80AAC0A4C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CED946-F4A8-C24C-A6DA-BD2627D6F1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944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E022CB-3D02-1B4F-841E-DE018BDD6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2453081-0A59-1244-B45A-AA0D2D67F6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4762F7-554D-E34C-A3DD-AE030B3D4E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46D7CA-F115-1B41-8DF9-AC61BF628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D61EFA-B3A1-C442-89E4-0AE923449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531CB6-9230-FB4A-84ED-FD6D385D0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780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BAF5F41-1579-A24F-A466-EE012090CD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FAB8E2-733C-0C44-8972-CE6D7845E4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E5B314-1FC4-DC40-8D1B-57D2252FED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DDC9C2-2FD4-D142-8295-6FFB674C28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299995-9E3D-E54E-A29C-ECE6B57766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6621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1905" y="805434"/>
            <a:ext cx="5425440" cy="559003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072187" y="66675"/>
            <a:ext cx="9048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6</a:t>
            </a:r>
          </a:p>
        </p:txBody>
      </p:sp>
      <p:sp>
        <p:nvSpPr>
          <p:cNvPr id="6" name="Rectangle 5"/>
          <p:cNvSpPr/>
          <p:nvPr/>
        </p:nvSpPr>
        <p:spPr>
          <a:xfrm>
            <a:off x="3519619" y="436006"/>
            <a:ext cx="2509838" cy="45547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426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2">
            <a:lum bright="-2000" contras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9944" y="1981200"/>
            <a:ext cx="2651760" cy="214142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8"/>
          <p:cNvSpPr txBox="1">
            <a:spLocks noChangeArrowheads="1"/>
          </p:cNvSpPr>
          <p:nvPr/>
        </p:nvSpPr>
        <p:spPr bwMode="auto">
          <a:xfrm>
            <a:off x="4978344" y="1745621"/>
            <a:ext cx="2667000" cy="276999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             </a:t>
            </a:r>
            <a:r>
              <a:rPr lang="en-US" altLang="en-US" sz="1200" dirty="0"/>
              <a:t>1      2      3     4</a:t>
            </a:r>
          </a:p>
        </p:txBody>
      </p:sp>
      <p:sp>
        <p:nvSpPr>
          <p:cNvPr id="7" name="Rectangle 6"/>
          <p:cNvSpPr/>
          <p:nvPr/>
        </p:nvSpPr>
        <p:spPr>
          <a:xfrm>
            <a:off x="5327595" y="2228850"/>
            <a:ext cx="1114424" cy="17526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5408126" y="4048348"/>
            <a:ext cx="1807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4971478" y="1179106"/>
            <a:ext cx="95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5088621" y="959182"/>
            <a:ext cx="1392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TXN3-Q23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5373299" y="959182"/>
            <a:ext cx="1392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TXN3-Q72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5614018" y="970876"/>
            <a:ext cx="14157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o protein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848225" y="72490"/>
            <a:ext cx="3048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iginal uncropped Fig. 6A</a:t>
            </a:r>
          </a:p>
        </p:txBody>
      </p:sp>
      <p:cxnSp>
        <p:nvCxnSpPr>
          <p:cNvPr id="30" name="Straight Arrow Connector 29"/>
          <p:cNvCxnSpPr/>
          <p:nvPr/>
        </p:nvCxnSpPr>
        <p:spPr>
          <a:xfrm>
            <a:off x="4651319" y="2390775"/>
            <a:ext cx="3619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3871341" y="2215128"/>
            <a:ext cx="11715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0070C0"/>
                </a:solidFill>
              </a:rPr>
              <a:t>Substrate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876619" y="3443615"/>
            <a:ext cx="11017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Released  phosphate</a:t>
            </a:r>
          </a:p>
        </p:txBody>
      </p:sp>
      <p:cxnSp>
        <p:nvCxnSpPr>
          <p:cNvPr id="34" name="Straight Arrow Connector 33"/>
          <p:cNvCxnSpPr/>
          <p:nvPr/>
        </p:nvCxnSpPr>
        <p:spPr>
          <a:xfrm>
            <a:off x="4660844" y="3705225"/>
            <a:ext cx="3619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22"/>
          <p:cNvPicPr>
            <a:picLocks noChangeAspect="1" noChangeArrowheads="1"/>
          </p:cNvPicPr>
          <p:nvPr/>
        </p:nvPicPr>
        <p:blipFill>
          <a:blip r:embed="rId3">
            <a:duotone>
              <a:prstClr val="black"/>
              <a:schemeClr val="accent4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4280" y="5857875"/>
            <a:ext cx="1495425" cy="38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xtBox 15"/>
          <p:cNvSpPr txBox="1"/>
          <p:nvPr/>
        </p:nvSpPr>
        <p:spPr>
          <a:xfrm rot="16200000">
            <a:off x="2196584" y="5141506"/>
            <a:ext cx="95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17" name="TextBox 16"/>
          <p:cNvSpPr txBox="1"/>
          <p:nvPr/>
        </p:nvSpPr>
        <p:spPr>
          <a:xfrm rot="16200000">
            <a:off x="2313727" y="4921582"/>
            <a:ext cx="1392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TXN3-Q23</a:t>
            </a:r>
          </a:p>
        </p:txBody>
      </p:sp>
      <p:sp>
        <p:nvSpPr>
          <p:cNvPr id="18" name="TextBox 17"/>
          <p:cNvSpPr txBox="1"/>
          <p:nvPr/>
        </p:nvSpPr>
        <p:spPr>
          <a:xfrm rot="16200000">
            <a:off x="2598405" y="4921582"/>
            <a:ext cx="1392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TXN3-Q72</a:t>
            </a:r>
          </a:p>
        </p:txBody>
      </p:sp>
      <p:sp>
        <p:nvSpPr>
          <p:cNvPr id="19" name="Rectangle 18"/>
          <p:cNvSpPr/>
          <p:nvPr/>
        </p:nvSpPr>
        <p:spPr>
          <a:xfrm>
            <a:off x="2424280" y="5857875"/>
            <a:ext cx="1080919" cy="381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2424280" y="6238875"/>
            <a:ext cx="1807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749722" y="5859572"/>
            <a:ext cx="8505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NKP</a:t>
            </a:r>
          </a:p>
        </p:txBody>
      </p:sp>
      <p:sp>
        <p:nvSpPr>
          <p:cNvPr id="22" name="TextBox 21"/>
          <p:cNvSpPr txBox="1"/>
          <p:nvPr/>
        </p:nvSpPr>
        <p:spPr>
          <a:xfrm rot="16200000">
            <a:off x="2959937" y="4977035"/>
            <a:ext cx="1392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ure PNKP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8595815" y="5159471"/>
            <a:ext cx="95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8712958" y="4939547"/>
            <a:ext cx="1392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TXN3-Q23</a:t>
            </a:r>
          </a:p>
        </p:txBody>
      </p:sp>
      <p:sp>
        <p:nvSpPr>
          <p:cNvPr id="26" name="TextBox 25"/>
          <p:cNvSpPr txBox="1"/>
          <p:nvPr/>
        </p:nvSpPr>
        <p:spPr>
          <a:xfrm rot="16200000">
            <a:off x="9022803" y="4939547"/>
            <a:ext cx="1392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TXN3-Q72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8989" y="5951055"/>
            <a:ext cx="1001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9E57216-6CAF-13CC-2C2D-E96C97F9D2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67823" y="5764819"/>
            <a:ext cx="1377815" cy="743776"/>
          </a:xfrm>
          <a:prstGeom prst="rect">
            <a:avLst/>
          </a:prstGeom>
        </p:spPr>
      </p:pic>
      <p:sp>
        <p:nvSpPr>
          <p:cNvPr id="29" name="Rectangle 28"/>
          <p:cNvSpPr/>
          <p:nvPr/>
        </p:nvSpPr>
        <p:spPr>
          <a:xfrm>
            <a:off x="8872416" y="5945872"/>
            <a:ext cx="1031228" cy="381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/>
          <p:cNvSpPr txBox="1"/>
          <p:nvPr/>
        </p:nvSpPr>
        <p:spPr>
          <a:xfrm>
            <a:off x="8958761" y="6228904"/>
            <a:ext cx="1803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</p:spTree>
    <p:extLst>
      <p:ext uri="{BB962C8B-B14F-4D97-AF65-F5344CB8AC3E}">
        <p14:creationId xmlns:p14="http://schemas.microsoft.com/office/powerpoint/2010/main" val="2329365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Roxo">
      <a:dk1>
        <a:sysClr val="windowText" lastClr="000000"/>
      </a:dk1>
      <a:lt1>
        <a:sysClr val="window" lastClr="FFFFFF"/>
      </a:lt1>
      <a:dk2>
        <a:srgbClr val="373545"/>
      </a:dk2>
      <a:lt2>
        <a:srgbClr val="DCD8DC"/>
      </a:lt2>
      <a:accent1>
        <a:srgbClr val="AD84C6"/>
      </a:accent1>
      <a:accent2>
        <a:srgbClr val="8784C7"/>
      </a:accent2>
      <a:accent3>
        <a:srgbClr val="5D739A"/>
      </a:accent3>
      <a:accent4>
        <a:srgbClr val="6997AF"/>
      </a:accent4>
      <a:accent5>
        <a:srgbClr val="84ACB6"/>
      </a:accent5>
      <a:accent6>
        <a:srgbClr val="6F8183"/>
      </a:accent6>
      <a:hlink>
        <a:srgbClr val="69A020"/>
      </a:hlink>
      <a:folHlink>
        <a:srgbClr val="8C8C8C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3</TotalTime>
  <Words>34</Words>
  <Application>Microsoft Office PowerPoint</Application>
  <PresentationFormat>Widescreen</PresentationFormat>
  <Paragraphs>2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a Sofia da Silva Correia</dc:creator>
  <cp:lastModifiedBy>Hazra, Tapas K.</cp:lastModifiedBy>
  <cp:revision>153</cp:revision>
  <cp:lastPrinted>2023-08-29T23:30:28Z</cp:lastPrinted>
  <dcterms:created xsi:type="dcterms:W3CDTF">2021-02-24T12:59:59Z</dcterms:created>
  <dcterms:modified xsi:type="dcterms:W3CDTF">2023-09-19T17:28:00Z</dcterms:modified>
</cp:coreProperties>
</file>